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120" y="6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68776A1-8FF3-AD54-8582-10206852930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8A19C8E-1966-62A1-9F04-5171F490F7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50818DE-5E1B-5F1D-DD02-3B2EE2FB8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36E4-49DE-4A57-ABFC-6C490D7F6779}" type="datetimeFigureOut">
              <a:rPr kumimoji="1" lang="ja-JP" altLang="en-US" smtClean="0"/>
              <a:t>2023/7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2663076-90F6-F9FA-164C-74D09C6823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1F6DDB-5938-8000-3A13-17CEA38920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00DB-5236-414D-BF12-A6F99DC5B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6053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C9BEED-1C95-85C7-ED9A-BE8D35EDE0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078C9F3-4929-617A-889E-CB122F74EB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2E64C08-177D-0245-2A22-84CC21094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36E4-49DE-4A57-ABFC-6C490D7F6779}" type="datetimeFigureOut">
              <a:rPr kumimoji="1" lang="ja-JP" altLang="en-US" smtClean="0"/>
              <a:t>2023/7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82D0EFB-1A0C-96C3-A727-A949BC75A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5636243-B9A3-A6C6-A931-652F2DEEF1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00DB-5236-414D-BF12-A6F99DC5B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56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F979076-0949-6663-6BB9-41F7C881FF4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947331A-8079-8AC1-541F-1B9FC73E16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E97AF93-45BF-D5D7-8AC8-5CB04E620C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36E4-49DE-4A57-ABFC-6C490D7F6779}" type="datetimeFigureOut">
              <a:rPr kumimoji="1" lang="ja-JP" altLang="en-US" smtClean="0"/>
              <a:t>2023/7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4F3DFF1-E2DD-4404-0AF5-53A258C2F1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63D098-D0B6-3B86-4D12-59DD8F5E0C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00DB-5236-414D-BF12-A6F99DC5B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27233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750832-177D-A71D-1317-DEA6EE5212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3927B2F-3FFC-97E7-D25D-6D0D2E65D7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96366B8-1786-7007-4AB2-D1755F45DA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36E4-49DE-4A57-ABFC-6C490D7F6779}" type="datetimeFigureOut">
              <a:rPr kumimoji="1" lang="ja-JP" altLang="en-US" smtClean="0"/>
              <a:t>2023/7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4791ABD-6702-A217-43E6-A56B22F302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90DE87-C7D9-5319-9168-42C5561B09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00DB-5236-414D-BF12-A6F99DC5B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7689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7C5E2C-37FA-9B2B-8917-8C752748B4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576138A-2AF4-2E17-BDF2-48724881D0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4ABB287-774E-8BF1-4564-4A177D1AD5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36E4-49DE-4A57-ABFC-6C490D7F6779}" type="datetimeFigureOut">
              <a:rPr kumimoji="1" lang="ja-JP" altLang="en-US" smtClean="0"/>
              <a:t>2023/7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8DCB3CC-CB2B-7113-929F-A52CAC86B3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037084F-93B8-4655-E1E0-1262C6E1D2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00DB-5236-414D-BF12-A6F99DC5B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2950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0A0ECDD-8BFF-E2D9-724C-5E944CAB17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A75372C-746F-DD54-E9A6-E80190B182B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4B48463-6A98-4FBC-E752-728B211FEB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19CAEDA-E964-2580-FCA2-421D878E19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36E4-49DE-4A57-ABFC-6C490D7F6779}" type="datetimeFigureOut">
              <a:rPr kumimoji="1" lang="ja-JP" altLang="en-US" smtClean="0"/>
              <a:t>2023/7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E0AD217-C4D9-C69E-FEE5-EACD8DD08A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1E680B5-180C-03F1-A628-72BE82E00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00DB-5236-414D-BF12-A6F99DC5B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0244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F5BD156-688F-1A8A-F7AD-0C9E659327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DC622F8-0B3C-FD2F-C582-568AAFD39E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C8BDA0B-2020-0A69-E907-11FA546328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2983822-C0BD-E50A-4FB1-FE90CBB1650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3EAD682-6945-2159-BE55-0D9D8ACEDE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E8DA03F-D0B8-B003-6060-E608FB3DA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36E4-49DE-4A57-ABFC-6C490D7F6779}" type="datetimeFigureOut">
              <a:rPr kumimoji="1" lang="ja-JP" altLang="en-US" smtClean="0"/>
              <a:t>2023/7/2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6031ABA-282A-DF47-2184-9753FF4B7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F4217F3-598E-3F48-D954-E94FCF6F88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00DB-5236-414D-BF12-A6F99DC5B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0233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3C6109-8EE1-9047-2F3C-AB926281E4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5220046-6EFD-67F6-8195-5B46FD603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36E4-49DE-4A57-ABFC-6C490D7F6779}" type="datetimeFigureOut">
              <a:rPr kumimoji="1" lang="ja-JP" altLang="en-US" smtClean="0"/>
              <a:t>2023/7/2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A5AAAC6-781E-97DD-99F7-FF00861AD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4063EED-765A-2806-C667-7722322DEE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00DB-5236-414D-BF12-A6F99DC5B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645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9CDCA5A-C432-A963-5404-F6D3F9B113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36E4-49DE-4A57-ABFC-6C490D7F6779}" type="datetimeFigureOut">
              <a:rPr kumimoji="1" lang="ja-JP" altLang="en-US" smtClean="0"/>
              <a:t>2023/7/2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DFAA9FF-DD78-2616-A92B-E93638A35A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6AE8AAF-17C3-9D43-7B7E-3079086F5B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00DB-5236-414D-BF12-A6F99DC5B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0481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0BE7B1-B2AD-1D55-5071-528DABC52B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C18DA2D-7AFD-2DA4-94E0-850B62A2EB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F940446-E6F8-E2F2-05D1-C2A2DCB5AA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655AF9D-7AC3-3912-11D1-ADAE4F64D1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36E4-49DE-4A57-ABFC-6C490D7F6779}" type="datetimeFigureOut">
              <a:rPr kumimoji="1" lang="ja-JP" altLang="en-US" smtClean="0"/>
              <a:t>2023/7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B97B909-22F0-C9E0-672F-D197618557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0CE42EA-C92F-A0E3-B18A-F78E107033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00DB-5236-414D-BF12-A6F99DC5B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4796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42E218-91E5-7913-AD35-3918CE8142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DDA3C12-4569-1325-3E69-0DB7822628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936C6E4-1EFB-CC6C-074D-E345204FBE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F990370-6C76-5DF4-E338-D4CAC4DD7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36E4-49DE-4A57-ABFC-6C490D7F6779}" type="datetimeFigureOut">
              <a:rPr kumimoji="1" lang="ja-JP" altLang="en-US" smtClean="0"/>
              <a:t>2023/7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ABC91F1-58D3-3350-057B-1DEA363572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DEE2811-CD11-0C6F-EB8F-EF5891A3F5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00DB-5236-414D-BF12-A6F99DC5B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6900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F7299D4-5A99-5E49-8A10-E0E57A63A3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92000B0-F345-ADA1-AD16-93765A4849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689B7EB-6884-F059-BAD5-4ED7B9EC38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0A36E4-49DE-4A57-ABFC-6C490D7F6779}" type="datetimeFigureOut">
              <a:rPr kumimoji="1" lang="ja-JP" altLang="en-US" smtClean="0"/>
              <a:t>2023/7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89F21C4-6132-F855-C041-5E2176BA2E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9C0AB2A-09A4-ABC7-1B24-879A30C099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D400DB-5236-414D-BF12-A6F99DC5B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456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F732D27-A962-0E98-34E5-E6D8402C5DA7}"/>
              </a:ext>
            </a:extLst>
          </p:cNvPr>
          <p:cNvSpPr txBox="1"/>
          <p:nvPr/>
        </p:nvSpPr>
        <p:spPr>
          <a:xfrm>
            <a:off x="1186654" y="692942"/>
            <a:ext cx="97096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r>
              <a:rPr kumimoji="1"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case of esophageal submucosal hematoma in the absence of antithrombotic medication or predisposition to bleeding (12 cases).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14B89D2-E9DF-5413-E183-9EFFB4E5EE15}"/>
              </a:ext>
            </a:extLst>
          </p:cNvPr>
          <p:cNvSpPr txBox="1"/>
          <p:nvPr/>
        </p:nvSpPr>
        <p:spPr>
          <a:xfrm>
            <a:off x="998764" y="4064928"/>
            <a:ext cx="10615749" cy="279307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 rtl="0" fontAlgn="base">
              <a:buFont typeface="+mj-lt"/>
              <a:buAutoNum type="arabicPeriod"/>
            </a:pPr>
            <a:r>
              <a:rPr lang="en-US" altLang="ja-JP" sz="1050" dirty="0" err="1">
                <a:solidFill>
                  <a:srgbClr val="212121"/>
                </a:solidFill>
                <a:latin typeface="Times New Roman"/>
                <a:ea typeface="游ゴシック"/>
                <a:cs typeface="Times New Roman"/>
              </a:rPr>
              <a:t>Meininge</a:t>
            </a:r>
            <a:r>
              <a:rPr lang="en-US" altLang="ja-JP" sz="1050" b="0" i="0" dirty="0">
                <a:solidFill>
                  <a:srgbClr val="212121"/>
                </a:solidFill>
                <a:effectLst/>
                <a:latin typeface="Times New Roman"/>
                <a:ea typeface="游ゴシック"/>
                <a:cs typeface="Times New Roman"/>
              </a:rPr>
              <a:t> M, </a:t>
            </a:r>
            <a:r>
              <a:rPr lang="en-US" altLang="ja-JP" sz="1050" b="0" i="0" dirty="0" err="1">
                <a:solidFill>
                  <a:srgbClr val="212121"/>
                </a:solidFill>
                <a:effectLst/>
                <a:latin typeface="Times New Roman"/>
                <a:ea typeface="游ゴシック"/>
                <a:cs typeface="Times New Roman"/>
              </a:rPr>
              <a:t>Bains</a:t>
            </a:r>
            <a:r>
              <a:rPr lang="en-US" altLang="ja-JP" sz="1050" b="0" i="0" dirty="0">
                <a:solidFill>
                  <a:srgbClr val="212121"/>
                </a:solidFill>
                <a:effectLst/>
                <a:latin typeface="Times New Roman"/>
                <a:ea typeface="游ゴシック"/>
                <a:cs typeface="Times New Roman"/>
              </a:rPr>
              <a:t> M, Yusuf S, </a:t>
            </a:r>
            <a:r>
              <a:rPr lang="en-US" altLang="ja-JP" sz="1050" b="0" i="0" dirty="0" err="1">
                <a:solidFill>
                  <a:srgbClr val="212121"/>
                </a:solidFill>
                <a:effectLst/>
                <a:latin typeface="Times New Roman"/>
                <a:ea typeface="游ゴシック"/>
                <a:cs typeface="Times New Roman"/>
              </a:rPr>
              <a:t>Gerdes</a:t>
            </a:r>
            <a:r>
              <a:rPr lang="en-US" altLang="ja-JP" sz="1050" b="0" i="0" dirty="0">
                <a:solidFill>
                  <a:srgbClr val="212121"/>
                </a:solidFill>
                <a:effectLst/>
                <a:latin typeface="Times New Roman"/>
                <a:ea typeface="游ゴシック"/>
                <a:cs typeface="Times New Roman"/>
              </a:rPr>
              <a:t> H. Esophageal intramural hematoma: a painful condition that may mimic an esophageal mass. </a:t>
            </a:r>
            <a:r>
              <a:rPr lang="en-US" altLang="ja-JP" sz="1050" b="0" i="0" dirty="0" err="1">
                <a:solidFill>
                  <a:srgbClr val="212121"/>
                </a:solidFill>
                <a:effectLst/>
                <a:latin typeface="Times New Roman"/>
                <a:ea typeface="游ゴシック"/>
                <a:cs typeface="Times New Roman"/>
              </a:rPr>
              <a:t>Gastrointest</a:t>
            </a:r>
            <a:r>
              <a:rPr lang="en-US" altLang="ja-JP" sz="1050" b="0" i="0" dirty="0">
                <a:solidFill>
                  <a:srgbClr val="212121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</a:t>
            </a:r>
            <a:r>
              <a:rPr lang="en-US" altLang="ja-JP" sz="1050" b="0" i="0" dirty="0" err="1">
                <a:solidFill>
                  <a:srgbClr val="212121"/>
                </a:solidFill>
                <a:effectLst/>
                <a:latin typeface="Times New Roman"/>
                <a:ea typeface="游ゴシック"/>
                <a:cs typeface="Times New Roman"/>
              </a:rPr>
              <a:t>Endosc</a:t>
            </a:r>
            <a:r>
              <a:rPr lang="en-US" altLang="ja-JP" sz="1050" b="0" i="0" dirty="0">
                <a:solidFill>
                  <a:srgbClr val="212121"/>
                </a:solidFill>
                <a:effectLst/>
                <a:latin typeface="Times New Roman"/>
                <a:ea typeface="游ゴシック"/>
                <a:cs typeface="Times New Roman"/>
              </a:rPr>
              <a:t> 2002; </a:t>
            </a:r>
            <a:r>
              <a:rPr lang="en-US" altLang="ja-JP" sz="1050" dirty="0">
                <a:solidFill>
                  <a:srgbClr val="212121"/>
                </a:solidFill>
                <a:latin typeface="Times New Roman"/>
                <a:ea typeface="游ゴシック"/>
                <a:cs typeface="Times New Roman"/>
              </a:rPr>
              <a:t>56:</a:t>
            </a:r>
            <a:r>
              <a:rPr lang="en-US" altLang="ja-JP" sz="1050" b="0" i="0" dirty="0">
                <a:solidFill>
                  <a:srgbClr val="212121"/>
                </a:solidFill>
                <a:effectLst/>
                <a:latin typeface="Times New Roman"/>
                <a:ea typeface="游ゴシック"/>
                <a:cs typeface="Times New Roman"/>
              </a:rPr>
              <a:t> 767-70.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  </a:t>
            </a:r>
          </a:p>
          <a:p>
            <a:pPr algn="just" fontAlgn="base">
              <a:buFont typeface="+mj-lt"/>
              <a:buAutoNum type="arabicPeriod" startAt="2"/>
            </a:pP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Lu MS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,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Liu YH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,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Liu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HP, Wu YC, Chu YY, Chu JJ.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Spontaneous intramural esophageal hematoma. Ann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Thorac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Surg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2004;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78: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343-5.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 </a:t>
            </a:r>
            <a:endParaRPr lang="en-US" altLang="ja-JP" sz="1050" b="0" i="0" dirty="0">
              <a:solidFill>
                <a:srgbClr val="000000"/>
              </a:solidFill>
              <a:effectLst/>
              <a:latin typeface="Times New Roman"/>
              <a:ea typeface="游明朝" panose="02020400000000000000" pitchFamily="18" charset="-128"/>
              <a:cs typeface="Times New Roman"/>
            </a:endParaRPr>
          </a:p>
          <a:p>
            <a:pPr algn="just" rtl="0" fontAlgn="base">
              <a:buFont typeface="+mj-lt"/>
              <a:buAutoNum type="arabicPeriod" startAt="3"/>
            </a:pP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Lauzon SC,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Heitmiller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RF. Transient esophageal obstruction in a young man: an intramural esophageal hematoma? Dis Esophagus. 2005;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18: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127-9.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 </a:t>
            </a:r>
            <a:endParaRPr lang="en-US" altLang="ja-JP" sz="1050" b="0" i="0" dirty="0">
              <a:solidFill>
                <a:srgbClr val="000000"/>
              </a:solidFill>
              <a:effectLst/>
              <a:latin typeface="Times New Roman"/>
              <a:ea typeface="游明朝" panose="02020400000000000000" pitchFamily="18" charset="-128"/>
              <a:cs typeface="Times New Roman"/>
            </a:endParaRPr>
          </a:p>
          <a:p>
            <a:pPr algn="just" fontAlgn="base">
              <a:buFont typeface="+mj-lt"/>
              <a:buAutoNum type="arabicPeriod" startAt="4"/>
            </a:pP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Modi P, Edwards A, Fox B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, </a:t>
            </a:r>
            <a:r>
              <a:rPr lang="en-US" altLang="ja-JP" sz="1050" dirty="0" err="1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Rahamim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 J.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Dissecting intramural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haematoma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of the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oesophagus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.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Eur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J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Cardiothorac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Surg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2005;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27: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171-3.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 </a:t>
            </a:r>
            <a:endParaRPr lang="en-US" altLang="ja-JP" sz="1050" b="0" i="0" dirty="0">
              <a:solidFill>
                <a:srgbClr val="000000"/>
              </a:solidFill>
              <a:effectLst/>
              <a:latin typeface="Times New Roman"/>
              <a:ea typeface="游明朝" panose="02020400000000000000" pitchFamily="18" charset="-128"/>
              <a:cs typeface="Times New Roman"/>
            </a:endParaRPr>
          </a:p>
          <a:p>
            <a:pPr algn="just" fontAlgn="base">
              <a:buFont typeface="+mj-lt"/>
              <a:buAutoNum type="arabicPeriod" startAt="5"/>
            </a:pP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Chu YY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,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Sung KF, Ng SC, Cheng HT, Chiu CT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. Achalasia combined with esophageal intramural hematoma: Case report and literature review. World J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Gastroenterol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2010;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16: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5391-4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. </a:t>
            </a:r>
            <a:endParaRPr lang="en-US" altLang="ja-JP" sz="1050" b="0" i="0" dirty="0">
              <a:solidFill>
                <a:srgbClr val="000000"/>
              </a:solidFill>
              <a:effectLst/>
              <a:latin typeface="Times New Roman"/>
              <a:ea typeface="游明朝" panose="02020400000000000000" pitchFamily="18" charset="-128"/>
              <a:cs typeface="Times New Roman"/>
            </a:endParaRPr>
          </a:p>
          <a:p>
            <a:pPr algn="just" fontAlgn="base">
              <a:buFont typeface="+mj-lt"/>
              <a:buAutoNum type="arabicPeriod" startAt="6"/>
            </a:pP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Lin IT, Bair MJ, Chen HL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Wu CH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. Pill-related esophageal intramural hematoma and dissection.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Gastrointest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Endosc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2010;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72: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432-3.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 </a:t>
            </a:r>
            <a:endParaRPr lang="en-US" altLang="ja-JP" sz="1050" b="0" i="0" dirty="0">
              <a:solidFill>
                <a:srgbClr val="000000"/>
              </a:solidFill>
              <a:effectLst/>
              <a:latin typeface="Times New Roman"/>
              <a:ea typeface="游明朝" panose="02020400000000000000" pitchFamily="18" charset="-128"/>
              <a:cs typeface="Times New Roman"/>
            </a:endParaRPr>
          </a:p>
          <a:p>
            <a:pPr algn="just" rtl="0" fontAlgn="base">
              <a:buFont typeface="+mj-lt"/>
              <a:buAutoNum type="arabicPeriod" startAt="7"/>
            </a:pP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Choi H, Kang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HY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, Song IH. Intramural perforation with hematoma of the esophagus.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Clin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 Res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Hepatol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Gastroenterol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 2012;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36: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101-2.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 </a:t>
            </a:r>
            <a:endParaRPr lang="en-US" altLang="ja-JP" sz="1050" b="0" i="0" dirty="0">
              <a:solidFill>
                <a:srgbClr val="000000"/>
              </a:solidFill>
              <a:effectLst/>
              <a:latin typeface="Times New Roman"/>
              <a:cs typeface="Times New Roman"/>
            </a:endParaRPr>
          </a:p>
          <a:p>
            <a:pPr algn="just" rtl="0" fontAlgn="base">
              <a:buFont typeface="+mj-lt"/>
              <a:buAutoNum type="arabicPeriod" startAt="8"/>
            </a:pPr>
            <a:r>
              <a:rPr lang="en-US" altLang="ja-JP" sz="1050" b="0" i="0" dirty="0" err="1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ncannon</a:t>
            </a:r>
            <a:r>
              <a:rPr lang="en-US" altLang="ja-JP" sz="1050" b="0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ES, Khan F, </a:t>
            </a:r>
            <a:r>
              <a:rPr lang="en-US" altLang="ja-JP" sz="1050" b="0" i="0" dirty="0" err="1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'Hanrahan</a:t>
            </a:r>
            <a:r>
              <a:rPr lang="en-US" altLang="ja-JP" sz="1050" b="0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. Spontaneous intramural </a:t>
            </a:r>
            <a:r>
              <a:rPr lang="en-US" altLang="ja-JP" sz="1050" b="0" i="0" dirty="0" err="1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esophageal</a:t>
            </a:r>
            <a:r>
              <a:rPr lang="en-US" altLang="ja-JP" sz="1050" b="0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b="0" i="0" dirty="0" err="1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aematoma</a:t>
            </a:r>
            <a:r>
              <a:rPr lang="en-US" altLang="ja-JP" sz="1050" b="0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n unusual cause of chest pain. BMJ Case Rep 2011; 2011: bcr0920114837.</a:t>
            </a:r>
            <a:r>
              <a:rPr lang="en-US" altLang="ja-JP" sz="1050" b="0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altLang="ja-JP" sz="1050" b="0" i="0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fontAlgn="base">
              <a:buFont typeface="+mj-lt"/>
              <a:buAutoNum type="arabicPeriod" startAt="9"/>
            </a:pPr>
            <a:r>
              <a:rPr lang="en-US" altLang="ja-JP" sz="1050" dirty="0" err="1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Pomara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 C, Bello S, </a:t>
            </a:r>
            <a:r>
              <a:rPr lang="en-US" altLang="ja-JP" sz="1050" dirty="0" err="1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D'Errico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 S, Greco M, </a:t>
            </a:r>
            <a:r>
              <a:rPr lang="en-US" altLang="ja-JP" sz="1050" dirty="0" err="1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Fineschi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 V.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Sudden death due to a dissecting intramural hematoma of the esophagus (DIHE) in a woman with severe neurofibromatosis-related scoliosis. Forensic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Sci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Int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2013;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228: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e71-5.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 </a:t>
            </a:r>
            <a:endParaRPr lang="en-US" altLang="ja-JP" sz="1050" b="0" i="0" dirty="0">
              <a:solidFill>
                <a:srgbClr val="000000"/>
              </a:solidFill>
              <a:effectLst/>
              <a:latin typeface="Times New Roman"/>
              <a:ea typeface="游明朝" panose="02020400000000000000" pitchFamily="18" charset="-128"/>
              <a:cs typeface="Times New Roman"/>
            </a:endParaRPr>
          </a:p>
          <a:p>
            <a:pPr algn="just" fontAlgn="base">
              <a:buFont typeface="+mj-lt"/>
              <a:buAutoNum type="arabicPeriod" startAt="10"/>
            </a:pP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Watanabe Y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,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Shimizu N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,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 </a:t>
            </a:r>
            <a:r>
              <a:rPr lang="en-US" altLang="ja-JP" sz="1050" dirty="0" err="1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Iwakawa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 M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et al. Successful Treatment of Rapidly Progressive Life-Threatening Esophageal Submucosal Hematoma in a Patient With van der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Hoeve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Syndrome. J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Clin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Med Res 2018;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明朝"/>
                <a:cs typeface="Times New Roman"/>
              </a:rPr>
              <a:t>10: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明朝"/>
                <a:cs typeface="Times New Roman"/>
              </a:rPr>
              <a:t> 154-7.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 </a:t>
            </a:r>
            <a:endParaRPr lang="en-US" altLang="ja-JP" sz="1050" b="0" i="0" dirty="0">
              <a:solidFill>
                <a:srgbClr val="000000"/>
              </a:solidFill>
              <a:effectLst/>
              <a:latin typeface="Times New Roman"/>
              <a:ea typeface="游明朝" panose="02020400000000000000" pitchFamily="18" charset="-128"/>
              <a:cs typeface="Times New Roman"/>
            </a:endParaRPr>
          </a:p>
          <a:p>
            <a:pPr algn="just" fontAlgn="base">
              <a:buFont typeface="+mj-lt"/>
              <a:buAutoNum type="arabicPeriod" startAt="11"/>
            </a:pP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Mogavero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 G,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Imperiali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 G,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Rondonotti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 E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, </a:t>
            </a:r>
            <a:r>
              <a:rPr lang="en-US" altLang="ja-JP" sz="1050" dirty="0" err="1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Martegani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 A, </a:t>
            </a:r>
            <a:r>
              <a:rPr lang="en-US" altLang="ja-JP" sz="1050" dirty="0" err="1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Spinzi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 G, </a:t>
            </a:r>
            <a:r>
              <a:rPr lang="en-US" altLang="ja-JP" sz="1050" dirty="0" err="1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Radaelli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 F.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Haematemesis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 and acute dysphagia: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oesophagogastroduodenoscopy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 or CT-which one first? Frontline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Gastroenterol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 2019;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10: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 112-154.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 </a:t>
            </a:r>
            <a:endParaRPr lang="en-US" altLang="ja-JP" sz="1050" b="0" i="0" dirty="0">
              <a:solidFill>
                <a:srgbClr val="000000"/>
              </a:solidFill>
              <a:effectLst/>
              <a:latin typeface="Times New Roman"/>
              <a:cs typeface="Times New Roman"/>
            </a:endParaRPr>
          </a:p>
          <a:p>
            <a:pPr algn="just" fontAlgn="base">
              <a:buFont typeface="+mj-lt"/>
              <a:buAutoNum type="arabicPeriod" startAt="12"/>
            </a:pPr>
            <a:r>
              <a:rPr lang="en-US" altLang="ja-JP" sz="1050" dirty="0" err="1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Fujiyoshi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 Y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, </a:t>
            </a:r>
            <a:r>
              <a:rPr lang="en-US" altLang="ja-JP" sz="1050" dirty="0" err="1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Fujiyoshi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 MRA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,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 Kimura R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 et al. Achalasia with esophageal intramural hematoma treated by per‐oral endoscopic </a:t>
            </a:r>
            <a:r>
              <a:rPr lang="en-US" altLang="ja-JP" sz="1050" b="0" i="0" dirty="0" err="1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myotomy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 (POEM). DEN Open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2022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; 2: </a:t>
            </a:r>
            <a:r>
              <a:rPr lang="en-US" altLang="ja-JP" sz="1050" dirty="0">
                <a:solidFill>
                  <a:srgbClr val="000000"/>
                </a:solidFill>
                <a:latin typeface="Times New Roman"/>
                <a:ea typeface="游ゴシック"/>
                <a:cs typeface="Times New Roman"/>
              </a:rPr>
              <a:t>e70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游ゴシック"/>
                <a:cs typeface="Times New Roman"/>
              </a:rPr>
              <a:t>.</a:t>
            </a:r>
            <a:r>
              <a:rPr lang="en-US" altLang="ja-JP" sz="1050" b="0" i="0" dirty="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 </a:t>
            </a:r>
            <a:endParaRPr lang="en-US" altLang="ja-JP" sz="1050" b="0" i="0" dirty="0">
              <a:solidFill>
                <a:srgbClr val="000000"/>
              </a:solidFill>
              <a:effectLst/>
              <a:latin typeface="Times New Roman"/>
              <a:cs typeface="Times New Roman"/>
            </a:endParaRPr>
          </a:p>
          <a:p>
            <a:endParaRPr kumimoji="1" lang="ja-JP" altLang="en-US" dirty="0"/>
          </a:p>
        </p:txBody>
      </p:sp>
      <p:graphicFrame>
        <p:nvGraphicFramePr>
          <p:cNvPr id="13" name="コンテンツ プレースホルダー 12">
            <a:extLst>
              <a:ext uri="{FF2B5EF4-FFF2-40B4-BE49-F238E27FC236}">
                <a16:creationId xmlns:a16="http://schemas.microsoft.com/office/drawing/2014/main" id="{FC212398-F5C0-F39D-8AFB-70FECBC200A0}"/>
              </a:ext>
            </a:extLst>
          </p:cNvPr>
          <p:cNvGraphicFramePr>
            <a:graphicFrameLocks noGrp="1"/>
          </p:cNvGraphicFramePr>
          <p:nvPr>
            <p:ph idx="1"/>
            <p:extLst/>
          </p:nvPr>
        </p:nvGraphicFramePr>
        <p:xfrm>
          <a:off x="998764" y="991621"/>
          <a:ext cx="10381192" cy="2729865"/>
        </p:xfrm>
        <a:graphic>
          <a:graphicData uri="http://schemas.openxmlformats.org/drawingml/2006/table">
            <a:tbl>
              <a:tblPr/>
              <a:tblGrid>
                <a:gridCol w="721705">
                  <a:extLst>
                    <a:ext uri="{9D8B030D-6E8A-4147-A177-3AD203B41FA5}">
                      <a16:colId xmlns:a16="http://schemas.microsoft.com/office/drawing/2014/main" val="1495369104"/>
                    </a:ext>
                  </a:extLst>
                </a:gridCol>
                <a:gridCol w="588056">
                  <a:extLst>
                    <a:ext uri="{9D8B030D-6E8A-4147-A177-3AD203B41FA5}">
                      <a16:colId xmlns:a16="http://schemas.microsoft.com/office/drawing/2014/main" val="9798777"/>
                    </a:ext>
                  </a:extLst>
                </a:gridCol>
                <a:gridCol w="872060">
                  <a:extLst>
                    <a:ext uri="{9D8B030D-6E8A-4147-A177-3AD203B41FA5}">
                      <a16:colId xmlns:a16="http://schemas.microsoft.com/office/drawing/2014/main" val="3135394721"/>
                    </a:ext>
                  </a:extLst>
                </a:gridCol>
                <a:gridCol w="551302">
                  <a:extLst>
                    <a:ext uri="{9D8B030D-6E8A-4147-A177-3AD203B41FA5}">
                      <a16:colId xmlns:a16="http://schemas.microsoft.com/office/drawing/2014/main" val="3079167232"/>
                    </a:ext>
                  </a:extLst>
                </a:gridCol>
                <a:gridCol w="534596">
                  <a:extLst>
                    <a:ext uri="{9D8B030D-6E8A-4147-A177-3AD203B41FA5}">
                      <a16:colId xmlns:a16="http://schemas.microsoft.com/office/drawing/2014/main" val="1038373663"/>
                    </a:ext>
                  </a:extLst>
                </a:gridCol>
                <a:gridCol w="1790898">
                  <a:extLst>
                    <a:ext uri="{9D8B030D-6E8A-4147-A177-3AD203B41FA5}">
                      <a16:colId xmlns:a16="http://schemas.microsoft.com/office/drawing/2014/main" val="39061239"/>
                    </a:ext>
                  </a:extLst>
                </a:gridCol>
                <a:gridCol w="3514972">
                  <a:extLst>
                    <a:ext uri="{9D8B030D-6E8A-4147-A177-3AD203B41FA5}">
                      <a16:colId xmlns:a16="http://schemas.microsoft.com/office/drawing/2014/main" val="2950444577"/>
                    </a:ext>
                  </a:extLst>
                </a:gridCol>
                <a:gridCol w="935543">
                  <a:extLst>
                    <a:ext uri="{9D8B030D-6E8A-4147-A177-3AD203B41FA5}">
                      <a16:colId xmlns:a16="http://schemas.microsoft.com/office/drawing/2014/main" val="2464064743"/>
                    </a:ext>
                  </a:extLst>
                </a:gridCol>
                <a:gridCol w="872060">
                  <a:extLst>
                    <a:ext uri="{9D8B030D-6E8A-4147-A177-3AD203B41FA5}">
                      <a16:colId xmlns:a16="http://schemas.microsoft.com/office/drawing/2014/main" val="180691656"/>
                    </a:ext>
                  </a:extLst>
                </a:gridCol>
              </a:tblGrid>
              <a:tr h="171450"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Year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Author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Age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Sex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Underlying conditions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Symptom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Treatment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Prognosis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8699739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00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Meininger M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2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M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GERD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hest pain, Dysphagia, Odynophagia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onseva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urvival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4885073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200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u MS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37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M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Hypertension, Hyperuricemia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hest pain, Dysphagia, Odynophagia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onseva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urvival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3210654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200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auzon SC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M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None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hest pain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onseva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urvival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7207301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4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200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Modi P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4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None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hest pain, Interscapular pain, Dysphagia, Odynophagia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onseva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urvival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9077931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2010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Chu YY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6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M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Hypertension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hest pain, Odynophagia, Hematemesis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onseva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urvival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3931803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6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2010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Lin IT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35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M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one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hest pain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onseva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urvival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9886446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7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2011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Choi H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31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M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lcoholic cirrhosis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etrosternal pain, Dyspnea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onseva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Death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3729011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8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2011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Concannon ES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29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M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cid reflux, waterbrash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hest pain, Nausea, Vomit, Dysphagia, Odynophagia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onseva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urvival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8493732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9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2013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Pomara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 C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3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F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Neurofibromatosis type 1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hest pain, Interscapular pain, Dysphagia, Odynophagia, Vomit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onseva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Death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113639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10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2018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Watanabe Y</a:t>
                      </a:r>
                      <a:endParaRPr lang="ja-JP" altLang="en-US"/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47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F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Van der Hoeve syndrome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bdominal pain, Vomit, Hematemesis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onseva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urvival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6033572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11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2019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Mogavero G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70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F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Hypertension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Vomit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onseva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urvival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1396752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1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2022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Fujiyoshi Y</a:t>
                      </a:r>
                      <a:endParaRPr lang="ja-JP" altLang="en-US"/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68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F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Ｐゴシック"/>
                          <a:cs typeface="Times New Roman"/>
                        </a:rPr>
                        <a:t>Achalasia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elena, Dysphagia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onsevativ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urvival</a:t>
                      </a:r>
                    </a:p>
                  </a:txBody>
                  <a:tcPr marL="9525" marR="9525" marT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19568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493529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250</Words>
  <Application>Microsoft Office PowerPoint</Application>
  <PresentationFormat>ワイド画面</PresentationFormat>
  <Paragraphs>12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游ゴシック</vt:lpstr>
      <vt:lpstr>游ゴシック Light</vt:lpstr>
      <vt:lpstr>游明朝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岩藤 恭昌</dc:creator>
  <cp:lastModifiedBy>岩藤　恭昌</cp:lastModifiedBy>
  <cp:revision>5</cp:revision>
  <dcterms:created xsi:type="dcterms:W3CDTF">2023-05-26T15:43:52Z</dcterms:created>
  <dcterms:modified xsi:type="dcterms:W3CDTF">2023-07-25T07:44:10Z</dcterms:modified>
</cp:coreProperties>
</file>